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0"/>
  </p:notesMasterIdLst>
  <p:sldIdLst>
    <p:sldId id="257" r:id="rId2"/>
    <p:sldId id="258" r:id="rId3"/>
    <p:sldId id="259" r:id="rId4"/>
    <p:sldId id="260" r:id="rId5"/>
    <p:sldId id="262" r:id="rId6"/>
    <p:sldId id="264" r:id="rId7"/>
    <p:sldId id="263" r:id="rId8"/>
    <p:sldId id="265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821"/>
    <p:restoredTop sz="93878"/>
  </p:normalViewPr>
  <p:slideViewPr>
    <p:cSldViewPr snapToGrid="0" snapToObjects="1">
      <p:cViewPr varScale="1">
        <p:scale>
          <a:sx n="115" d="100"/>
          <a:sy n="115" d="100"/>
        </p:scale>
        <p:origin x="45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291479-A4E9-1C45-9B3C-041FFA23FC73}" type="datetimeFigureOut">
              <a:rPr lang="en-US" smtClean="0"/>
              <a:t>7/8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893E24-DB81-224E-BB7A-B8871925B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10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 we get ready to have students and residents, the accreditation council of graduate medical education (ACGME) reminds us that we need to grow as a faculty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 think this is going to become a thing, an ongoing lecture series. If anyone has any feedback, suggestions for future topics, or would like to present a topic, please let me know. 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893E24-DB81-224E-BB7A-B8871925B59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65614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893E24-DB81-224E-BB7A-B8871925B59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233251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hy are we talking about this? COVID changed a lot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ue to COVID-19, our assessments of our learners are critically important to their growth as physicians and to our colleagues as they match their residency classes. Students probably missed a lot of clinical rotations, and they are generally being limited to 2 “audition” type experiences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*Author note: our faculty also precept medical students; this slide is included to make the points relevant to the audience. Please adapt as suits your site.*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893E24-DB81-224E-BB7A-B8871925B59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398861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ometimes people need to hear the, “I award you no points and may god have mercy on your soul” speech. On shift feedback is generally not that time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ur on shift assessments of learners are generally of the “shows how” and “does” variety. They require students to draw upon their foundational knowledge and apply it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is is where things get subjective bc EM isn’t black and white, ie, difference in imaging study ordering throughout the group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o our assessment of students isn’t necessarily how they conform to our practice but how they’re applying their foundational knowledge. 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893E24-DB81-224E-BB7A-B8871925B59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76236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sk just enough follow up questions to see where their knowledge/ability to apply it ends. Not looking to pimp people but to make sure they understand why we’re doing clinical things and find a teaching point or two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Example: “Looks like their troponin is back and negative, their HEART score is 3. I think they can go.”</a:t>
            </a:r>
            <a:b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</a:b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“What if they presented an hour after pain started, would you do anything differently?”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We should also pay attention to their work ethic and desire to be here because this can say a lot about how they will grow as a resident. Also looking for growth over multiple shifts if you work together more than once.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893E24-DB81-224E-BB7A-B8871925B59A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636856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You’re tired, you have notes to do. If you just write “honors” or all 5s the task goes away. But…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Generally end of shift assessment cards ask for a grade relative to expected level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Remember most learners are at their expected level, by definition. We can’t be certain how losing several months of clinical rotations will change this, but probably not for the better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any learners have strengths and weaknesses, and it’s okay to reward those strengths with a good number grade. But since our students will have a limited time in the clinical arena, we owe them honest feedback.</a:t>
            </a:r>
          </a:p>
          <a:p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ut that’s another talk. 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B893E24-DB81-224E-BB7A-B8871925B59A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2588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032BD1-8977-DD4F-A67D-10143DBE70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36D1BEC-3A4D-F141-AB3C-A828743AC3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88AFE6-77B5-6A4F-9B25-B2740E191D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526B-40CC-664A-A6F4-AE0C6CF334B5}" type="datetimeFigureOut">
              <a:rPr lang="en-US" smtClean="0"/>
              <a:t>7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C1E9D0-DFDA-9D48-BCBF-72349ACFF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469720-ABAC-7248-86B1-E63168F57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17DD6-9F55-BB41-9864-CE3C47F9DA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986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462F45-E2E9-0C40-B361-EA94058FD5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7DF9FA-460B-9345-9805-A4068D20F8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EB58D7-BE35-9147-8BD9-F8AD59F34D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526B-40CC-664A-A6F4-AE0C6CF334B5}" type="datetimeFigureOut">
              <a:rPr lang="en-US" smtClean="0"/>
              <a:t>7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B2C8D4-14DF-CF4B-B053-04934A36CD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B80FAE-45CE-8C4B-9A77-ED492DF115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17DD6-9F55-BB41-9864-CE3C47F9DA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2616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EBE6C98-4419-4F46-988C-7A552610419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A1F3C4A-9DC1-394A-9810-06F779428B2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5DCAE3-E1D0-BC41-BDB6-14592AAD83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526B-40CC-664A-A6F4-AE0C6CF334B5}" type="datetimeFigureOut">
              <a:rPr lang="en-US" smtClean="0"/>
              <a:t>7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5B6C07-0097-7049-9BA6-EADF2ED794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326A49-632F-5943-A7BA-C26BED3D99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17DD6-9F55-BB41-9864-CE3C47F9DA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985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5298A1-9356-D945-9D20-2B65B4F6FA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BDAB02-454E-864A-81FC-E6B18348F66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BAAF4A-2C41-D64F-B761-EDA4F8704E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526B-40CC-664A-A6F4-AE0C6CF334B5}" type="datetimeFigureOut">
              <a:rPr lang="en-US" smtClean="0"/>
              <a:t>7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994AAD-7891-2746-A612-726813CF5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07B33A-FD14-CC4D-A328-64181DE8EA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17DD6-9F55-BB41-9864-CE3C47F9DA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7721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476FC0-D2F3-DF41-9112-8982D9D247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2A39FD-1F8D-7A40-A52F-21CDA9A2F4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C88026-713C-CF40-97EE-0BDD92594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526B-40CC-664A-A6F4-AE0C6CF334B5}" type="datetimeFigureOut">
              <a:rPr lang="en-US" smtClean="0"/>
              <a:t>7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95FE4D-8208-D24F-8C39-B60D6EE81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88525A-9C36-8246-987A-78BE0760B1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17DD6-9F55-BB41-9864-CE3C47F9DA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6354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7715F8-9199-9649-8A24-03C9F2DD3D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B92446-A668-0E4D-A741-9C101E8B59D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D760927-548E-4549-B2B0-E473C7516B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C4E336D-CAB6-D641-A50B-B7B7B4BDD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526B-40CC-664A-A6F4-AE0C6CF334B5}" type="datetimeFigureOut">
              <a:rPr lang="en-US" smtClean="0"/>
              <a:t>7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AB3F1F-57E7-C948-878A-B105A8A1B5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BF47D5-1A82-6143-814A-D3711442BD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17DD6-9F55-BB41-9864-CE3C47F9DA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7484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6CB6E8-CAC0-6C4D-9FE8-D30AE39C4B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A50917-7A96-B740-9654-7A6A89192D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D651C1B-6AF8-B747-8134-8DBD1C210C9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0879A02-4A48-B24D-AC39-008B050C7D9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7BBF045-4BE4-4F48-B85A-A35B97932FB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3DDDDC-6881-454C-B66B-AAE655EBE0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526B-40CC-664A-A6F4-AE0C6CF334B5}" type="datetimeFigureOut">
              <a:rPr lang="en-US" smtClean="0"/>
              <a:t>7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06C21D1-80A0-554F-9556-9AE385D13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202AD7F-7D97-3747-A6D2-0C2A6055B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17DD6-9F55-BB41-9864-CE3C47F9DA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3748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231CB5-CEB2-7242-A2D7-1879157382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34EC6A5-D44F-4144-8F6D-21E5BA1395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526B-40CC-664A-A6F4-AE0C6CF334B5}" type="datetimeFigureOut">
              <a:rPr lang="en-US" smtClean="0"/>
              <a:t>7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DE470D3-0557-6942-95AB-B92F5FB356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21A922D-F9E1-7D49-B0F3-3E7D7B32BC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17DD6-9F55-BB41-9864-CE3C47F9DA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56387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617A0DB-D83F-F049-9888-23E17E5808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526B-40CC-664A-A6F4-AE0C6CF334B5}" type="datetimeFigureOut">
              <a:rPr lang="en-US" smtClean="0"/>
              <a:t>7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EED71D3-36E9-7F40-B619-867E20A800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70B5CDB-45E5-1F4C-B46C-297A2898B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17DD6-9F55-BB41-9864-CE3C47F9DA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287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28818E-9C0C-274A-9257-A240EF4494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C4E2E3A-9BE4-B042-8181-03472B4806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389718D-C13E-E242-BC4F-28B7402486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336744-3FC9-3945-94C1-5AC2166903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526B-40CC-664A-A6F4-AE0C6CF334B5}" type="datetimeFigureOut">
              <a:rPr lang="en-US" smtClean="0"/>
              <a:t>7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BE4B6A6-C1CC-0040-8979-9BD6A86B6F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825546-8788-0846-9A57-5125A51C09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17DD6-9F55-BB41-9864-CE3C47F9DA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187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6F3AC0-E3F7-894A-9462-7020D93666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41E055C-F585-CD40-9B3F-891D64F4A9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5CF51AD-783A-FD45-BB0E-935EABE75E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45E1AAD-C022-EB45-9E82-8559EB4389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58526B-40CC-664A-A6F4-AE0C6CF334B5}" type="datetimeFigureOut">
              <a:rPr lang="en-US" smtClean="0"/>
              <a:t>7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A0D0849-985F-494A-A313-CE073491D8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F0C8A30-A780-0746-AD8C-3326B1CE6D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D17DD6-9F55-BB41-9864-CE3C47F9DA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6965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4A69813-04A2-7C47-BFCC-4F00024E97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ED07B3B-2C72-7443-8BB4-0E1EFF099F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811D4C-AF8C-F148-B93A-82E85375370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58526B-40CC-664A-A6F4-AE0C6CF334B5}" type="datetimeFigureOut">
              <a:rPr lang="en-US" smtClean="0"/>
              <a:t>7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F6161A-1A5A-8742-B7D0-B725F418AE6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4B90DF-4F52-9A4F-91F3-A3EE7B09C9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D17DD6-9F55-BB41-9864-CE3C47F9DAF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8449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hyperlink" Target="https://knowledgeplus.nejm.org/blog/verrocchio-leonardo-and-the-art-of-effective-feedback-to-residents" TargetMode="Externa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3F392B-0AC0-B041-AA93-55619CE5EB27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Assessment in Clinical Teaching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1987967-8149-F849-9545-7FE0890FE7D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[Presenter]</a:t>
            </a:r>
          </a:p>
          <a:p>
            <a:r>
              <a:rPr lang="en-US" dirty="0"/>
              <a:t>[Venue]</a:t>
            </a:r>
          </a:p>
          <a:p>
            <a:r>
              <a:rPr lang="en-US" dirty="0"/>
              <a:t>[Date]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B9B13D3-7150-19D8-72DF-B22541C598F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42398" y="6212829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175243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E46073-F4F7-3F42-A59B-82511EFCD3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Objectiv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0C85B9-9EEE-F345-B327-6620D2E3567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Discuss the role individual faculty play in the assessment of learners</a:t>
            </a:r>
          </a:p>
          <a:p>
            <a:r>
              <a:rPr lang="en-US" dirty="0"/>
              <a:t>Recognize how to assess learners in a way that is beneficial to their growth while simultaneously informing their summative evaluations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4751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7FC8AF-8E67-5E41-A18F-A231A5DD0D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y are you telling us about this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5AAA89-9AC4-5F44-B801-E79C3CAD8F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690688"/>
            <a:ext cx="10515600" cy="4351338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Consensus statement from Council of Residency Directors in EM (CORD) (and others):</a:t>
            </a:r>
            <a:br>
              <a:rPr lang="en-US" dirty="0"/>
            </a:br>
            <a:r>
              <a:rPr lang="en-US" dirty="0"/>
              <a:t>1. EM Rotations: Ideally each student will complete one home and one away EM rotation </a:t>
            </a:r>
          </a:p>
          <a:p>
            <a:pPr marL="0" indent="0">
              <a:buNone/>
            </a:pPr>
            <a:r>
              <a:rPr lang="en-US" dirty="0"/>
              <a:t>2. Standardized Letters of Evaluation (SLOEs): Each student is expected to have 2 EM clerkship SLOEs in their residency application portfolio</a:t>
            </a: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0291018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C8E8C0-5F28-C141-90B8-0F4A0C5EB7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at is our role as clinical faculty?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ED3C70-9452-BD42-AA7A-6BA5F3FB99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2400" dirty="0"/>
              <a:t>Direct observation of clinical skills and assessment of clinical reasoning</a:t>
            </a:r>
          </a:p>
          <a:p>
            <a:r>
              <a:rPr lang="en-US" sz="2400" dirty="0"/>
              <a:t>Feedback and coaching</a:t>
            </a:r>
          </a:p>
          <a:p>
            <a:r>
              <a:rPr lang="en-US" sz="2400" dirty="0"/>
              <a:t>Appropriate supervision</a:t>
            </a:r>
          </a:p>
          <a:p>
            <a:r>
              <a:rPr lang="en-US" sz="2400" dirty="0"/>
              <a:t>Provide robust assessment information to clinical competency committee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9079701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2FC619-4C62-504A-914E-FCAEE4CF69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at constitutes helpful assessment?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9E02A5-FB23-9144-B9D5-AEEBE7126D0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On shift assessments are generally of ”shows how” and “does” type clinical skills</a:t>
            </a:r>
          </a:p>
          <a:p>
            <a:r>
              <a:rPr lang="en-US" dirty="0"/>
              <a:t>Learners draw upon their foundational knowledge and apply it</a:t>
            </a:r>
          </a:p>
          <a:p>
            <a:r>
              <a:rPr lang="en-US" dirty="0"/>
              <a:t>Our assessment should be based on how students apply knowledge, not on how their plans conform to our practice</a:t>
            </a:r>
          </a:p>
        </p:txBody>
      </p:sp>
    </p:spTree>
    <p:extLst>
      <p:ext uri="{BB962C8B-B14F-4D97-AF65-F5344CB8AC3E}">
        <p14:creationId xmlns:p14="http://schemas.microsoft.com/office/powerpoint/2010/main" val="36934412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2FC619-4C62-504A-914E-FCAEE4CF69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What constitutes helpful assessment?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19E02A5-FB23-9144-B9D5-AEEBE7126D0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sk just enough follow up questions to see where their knowledge ends</a:t>
            </a:r>
          </a:p>
          <a:p>
            <a:r>
              <a:rPr lang="en-US" dirty="0"/>
              <a:t>Make sure our learner understands the process and uses this to generate a learning point or two</a:t>
            </a:r>
          </a:p>
          <a:p>
            <a:r>
              <a:rPr lang="en-US" dirty="0"/>
              <a:t>Any comments about work ethic/professionalism</a:t>
            </a:r>
          </a:p>
        </p:txBody>
      </p:sp>
    </p:spTree>
    <p:extLst>
      <p:ext uri="{BB962C8B-B14F-4D97-AF65-F5344CB8AC3E}">
        <p14:creationId xmlns:p14="http://schemas.microsoft.com/office/powerpoint/2010/main" val="24491143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10EBB9-EFA2-854C-8549-20407E0EA2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riting down an actual number on the form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1618D9-9777-0044-A727-685B36A0A7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Assessment tools grade relative to expected level</a:t>
            </a:r>
          </a:p>
          <a:p>
            <a:r>
              <a:rPr lang="en-US" dirty="0"/>
              <a:t>Reward strengths with good grade</a:t>
            </a:r>
          </a:p>
          <a:p>
            <a:r>
              <a:rPr lang="en-US" dirty="0"/>
              <a:t>Honest feedback helps evaluation, </a:t>
            </a:r>
            <a:r>
              <a:rPr lang="en-US"/>
              <a:t>helps learners grow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24104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3A730C-027C-6E42-A906-EC5FE5C8D0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7FB056-966F-FB43-9714-243506E836E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en-US" dirty="0"/>
              <a:t>Miller A, Archer J. Impact of workplace based assessment on Doctors' education and performance: A systematic review. </a:t>
            </a:r>
            <a:r>
              <a:rPr lang="en-US" i="1" dirty="0"/>
              <a:t>BMJ</a:t>
            </a:r>
            <a:r>
              <a:rPr lang="en-US" dirty="0"/>
              <a:t>. 2010;341(sep24 1):c5064-c5064. doi:10.1136/bmj.c5064 </a:t>
            </a:r>
          </a:p>
          <a:p>
            <a:r>
              <a:rPr lang="en-US" dirty="0"/>
              <a:t>Hardavella G, Aamli-Gagnat A, Saad N, Rousalova I, Sreter KB. How to give and receive feedback effectively. </a:t>
            </a:r>
            <a:r>
              <a:rPr lang="en-US" i="1" dirty="0"/>
              <a:t>Breathe</a:t>
            </a:r>
            <a:r>
              <a:rPr lang="en-US" dirty="0"/>
              <a:t> (Sheffield, England). Accessed April 6, 2022.  At: https://pubmed.ncbi.nlm.nih.gov/29209427/</a:t>
            </a:r>
          </a:p>
          <a:p>
            <a:r>
              <a:rPr lang="en-US" dirty="0"/>
              <a:t>Doolittle B. Verrocchio, Leonardo, and the Art of Effective Feedback to Residents. NEJM Knowledge+. April 1218. At: </a:t>
            </a:r>
            <a:r>
              <a:rPr lang="en-US" dirty="0">
                <a:hlinkClick r:id="rId2"/>
              </a:rPr>
              <a:t>https://knowledgeplus.nejm.org/blog/verrocchio-leonardo-and-the-art-of-effective-feedback-to-residents</a:t>
            </a:r>
            <a:r>
              <a:rPr lang="en-US" dirty="0"/>
              <a:t>/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666566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8</TotalTime>
  <Words>915</Words>
  <Application>Microsoft Macintosh PowerPoint</Application>
  <PresentationFormat>Widescreen</PresentationFormat>
  <Paragraphs>54</Paragraphs>
  <Slides>8</Slides>
  <Notes>6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Assessment in Clinical Teaching</vt:lpstr>
      <vt:lpstr>Objectives</vt:lpstr>
      <vt:lpstr>Why are you telling us about this?</vt:lpstr>
      <vt:lpstr>What is our role as clinical faculty?</vt:lpstr>
      <vt:lpstr>What constitutes helpful assessment?</vt:lpstr>
      <vt:lpstr>What constitutes helpful assessment?</vt:lpstr>
      <vt:lpstr>Writing down an actual number on the form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ssessment in Clinical Teaching</dc:title>
  <dc:creator>Willner, Keith</dc:creator>
  <cp:lastModifiedBy>Alisa Wray</cp:lastModifiedBy>
  <cp:revision>13</cp:revision>
  <dcterms:created xsi:type="dcterms:W3CDTF">2021-10-08T19:52:53Z</dcterms:created>
  <dcterms:modified xsi:type="dcterms:W3CDTF">2022-07-08T19:28:10Z</dcterms:modified>
</cp:coreProperties>
</file>